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253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93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2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005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19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2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7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931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892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9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675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926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802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824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36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9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06C38B-7DD7-4DC4-A91F-5F4B2392C564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4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845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hp\Desktop\srk mutant\srk mutant (2).jpg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92159" y="1371403"/>
            <a:ext cx="2308898" cy="18342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3" name="TextBox 32"/>
          <p:cNvSpPr txBox="1"/>
          <p:nvPr/>
        </p:nvSpPr>
        <p:spPr>
          <a:xfrm>
            <a:off x="4370455" y="162041"/>
            <a:ext cx="3613390" cy="7694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s for mutant AT5g03350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btained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tingham 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 Stock Centre (NASC)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ASC ID: N536814;SALK ID- SALK_036814) </a:t>
            </a:r>
          </a:p>
          <a:p>
            <a:pPr algn="just"/>
            <a:endParaRPr lang="en-US" sz="11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6195101" y="865749"/>
            <a:ext cx="0" cy="438279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4084670" y="818482"/>
            <a:ext cx="20619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cations of seeds followed by spreading on soil</a:t>
            </a:r>
          </a:p>
        </p:txBody>
      </p:sp>
      <p:grpSp>
        <p:nvGrpSpPr>
          <p:cNvPr id="77" name="Group 76"/>
          <p:cNvGrpSpPr/>
          <p:nvPr/>
        </p:nvGrpSpPr>
        <p:grpSpPr>
          <a:xfrm>
            <a:off x="4045500" y="3965556"/>
            <a:ext cx="3835279" cy="1928836"/>
            <a:chOff x="2536455" y="3400552"/>
            <a:chExt cx="3835279" cy="1928836"/>
          </a:xfrm>
        </p:grpSpPr>
        <p:pic>
          <p:nvPicPr>
            <p:cNvPr id="3" name="Picture 2" descr="C:\Users\hp\Desktop\slg mutant\slgM16fa 20190402_011034_Fl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2038" y="4003449"/>
              <a:ext cx="3239696" cy="1295295"/>
            </a:xfrm>
            <a:prstGeom prst="rect">
              <a:avLst/>
            </a:prstGeom>
            <a:noFill/>
          </p:spPr>
        </p:pic>
        <p:sp>
          <p:nvSpPr>
            <p:cNvPr id="32" name="TextBox 31"/>
            <p:cNvSpPr txBox="1"/>
            <p:nvPr/>
          </p:nvSpPr>
          <p:spPr>
            <a:xfrm>
              <a:off x="3148649" y="3767479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39" name="TextBox 3">
              <a:extLst>
                <a:ext uri="{FF2B5EF4-FFF2-40B4-BE49-F238E27FC236}">
                  <a16:creationId xmlns:a16="http://schemas.microsoft.com/office/drawing/2014/main" id="{84927CCF-25E5-45B9-96EE-DE76FFA078D9}"/>
                </a:ext>
              </a:extLst>
            </p:cNvPr>
            <p:cNvSpPr txBox="1"/>
            <p:nvPr/>
          </p:nvSpPr>
          <p:spPr>
            <a:xfrm>
              <a:off x="2673589" y="494764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</a:p>
          </p:txBody>
        </p:sp>
        <p:sp>
          <p:nvSpPr>
            <p:cNvPr id="40" name="TextBox 4">
              <a:extLst>
                <a:ext uri="{FF2B5EF4-FFF2-40B4-BE49-F238E27FC236}">
                  <a16:creationId xmlns:a16="http://schemas.microsoft.com/office/drawing/2014/main" id="{230CAE12-D751-4B21-B64D-BE3B1B1EEEB9}"/>
                </a:ext>
              </a:extLst>
            </p:cNvPr>
            <p:cNvSpPr txBox="1"/>
            <p:nvPr/>
          </p:nvSpPr>
          <p:spPr>
            <a:xfrm>
              <a:off x="2656220" y="482510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0</a:t>
              </a:r>
            </a:p>
          </p:txBody>
        </p:sp>
        <p:sp>
          <p:nvSpPr>
            <p:cNvPr id="41" name="TextBox 5">
              <a:extLst>
                <a:ext uri="{FF2B5EF4-FFF2-40B4-BE49-F238E27FC236}">
                  <a16:creationId xmlns:a16="http://schemas.microsoft.com/office/drawing/2014/main" id="{551EBECE-C69D-4A7D-AE81-AEFECAA51F03}"/>
                </a:ext>
              </a:extLst>
            </p:cNvPr>
            <p:cNvSpPr txBox="1"/>
            <p:nvPr/>
          </p:nvSpPr>
          <p:spPr>
            <a:xfrm>
              <a:off x="2632376" y="4737867"/>
              <a:ext cx="48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</a:p>
          </p:txBody>
        </p:sp>
        <p:sp>
          <p:nvSpPr>
            <p:cNvPr id="42" name="TextBox 6">
              <a:extLst>
                <a:ext uri="{FF2B5EF4-FFF2-40B4-BE49-F238E27FC236}">
                  <a16:creationId xmlns:a16="http://schemas.microsoft.com/office/drawing/2014/main" id="{A2D114EF-EA79-4616-B713-60C316B545F5}"/>
                </a:ext>
              </a:extLst>
            </p:cNvPr>
            <p:cNvSpPr txBox="1"/>
            <p:nvPr/>
          </p:nvSpPr>
          <p:spPr>
            <a:xfrm>
              <a:off x="2632376" y="462339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0</a:t>
              </a:r>
            </a:p>
          </p:txBody>
        </p:sp>
        <p:sp>
          <p:nvSpPr>
            <p:cNvPr id="43" name="TextBox 15">
              <a:extLst>
                <a:ext uri="{FF2B5EF4-FFF2-40B4-BE49-F238E27FC236}">
                  <a16:creationId xmlns:a16="http://schemas.microsoft.com/office/drawing/2014/main" id="{14762094-1EAB-458D-8390-9D519721EE89}"/>
                </a:ext>
              </a:extLst>
            </p:cNvPr>
            <p:cNvSpPr txBox="1"/>
            <p:nvPr/>
          </p:nvSpPr>
          <p:spPr>
            <a:xfrm>
              <a:off x="2536455" y="4219174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0</a:t>
              </a:r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83030DB1-2EB3-46EA-BF22-AF3CBF90B9F5}"/>
                </a:ext>
              </a:extLst>
            </p:cNvPr>
            <p:cNvCxnSpPr/>
            <p:nvPr/>
          </p:nvCxnSpPr>
          <p:spPr>
            <a:xfrm>
              <a:off x="2933113" y="4328301"/>
              <a:ext cx="16903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2CD44D92-C142-4457-81EE-DEB33709E3F1}"/>
                </a:ext>
              </a:extLst>
            </p:cNvPr>
            <p:cNvCxnSpPr/>
            <p:nvPr/>
          </p:nvCxnSpPr>
          <p:spPr>
            <a:xfrm>
              <a:off x="2944358" y="4726588"/>
              <a:ext cx="16903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F35E0EDA-CA61-4AE1-8F2E-09AEFBD81288}"/>
                </a:ext>
              </a:extLst>
            </p:cNvPr>
            <p:cNvCxnSpPr/>
            <p:nvPr/>
          </p:nvCxnSpPr>
          <p:spPr>
            <a:xfrm>
              <a:off x="2938188" y="4842692"/>
              <a:ext cx="16903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67C051D4-367B-4348-B51E-DC2F4FEA7BC8}"/>
                </a:ext>
              </a:extLst>
            </p:cNvPr>
            <p:cNvCxnSpPr/>
            <p:nvPr/>
          </p:nvCxnSpPr>
          <p:spPr>
            <a:xfrm>
              <a:off x="2951775" y="4940631"/>
              <a:ext cx="16903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6C4ADF49-DEC1-4CA0-BFD6-3C4199E851BB}"/>
                </a:ext>
              </a:extLst>
            </p:cNvPr>
            <p:cNvCxnSpPr/>
            <p:nvPr/>
          </p:nvCxnSpPr>
          <p:spPr>
            <a:xfrm>
              <a:off x="2951775" y="5049940"/>
              <a:ext cx="16903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7F2FDAAA-66EE-4AB2-9A35-48FCA465C3E1}"/>
                </a:ext>
              </a:extLst>
            </p:cNvPr>
            <p:cNvCxnSpPr/>
            <p:nvPr/>
          </p:nvCxnSpPr>
          <p:spPr>
            <a:xfrm>
              <a:off x="2938188" y="5206723"/>
              <a:ext cx="16903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tangle 49"/>
            <p:cNvSpPr/>
            <p:nvPr/>
          </p:nvSpPr>
          <p:spPr>
            <a:xfrm>
              <a:off x="2661581" y="5113944"/>
              <a:ext cx="3385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</a:t>
              </a:r>
            </a:p>
          </p:txBody>
        </p:sp>
        <p:grpSp>
          <p:nvGrpSpPr>
            <p:cNvPr id="51" name="Group 50"/>
            <p:cNvGrpSpPr/>
            <p:nvPr/>
          </p:nvGrpSpPr>
          <p:grpSpPr>
            <a:xfrm>
              <a:off x="3496564" y="3400552"/>
              <a:ext cx="611065" cy="661732"/>
              <a:chOff x="3739167" y="4100347"/>
              <a:chExt cx="611065" cy="661732"/>
            </a:xfrm>
          </p:grpSpPr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3739167" y="4100347"/>
                <a:ext cx="61106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nt 1</a:t>
                </a:r>
              </a:p>
            </p:txBody>
          </p:sp>
          <p:sp>
            <p:nvSpPr>
              <p:cNvPr id="53" name="Rectangle 52"/>
              <p:cNvSpPr/>
              <p:nvPr/>
            </p:nvSpPr>
            <p:spPr>
              <a:xfrm rot="17965567">
                <a:off x="3656920" y="4386536"/>
                <a:ext cx="42832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</a:t>
                </a:r>
              </a:p>
            </p:txBody>
          </p:sp>
          <p:sp>
            <p:nvSpPr>
              <p:cNvPr id="54" name="Rectangle 53"/>
              <p:cNvSpPr/>
              <p:nvPr/>
            </p:nvSpPr>
            <p:spPr>
              <a:xfrm rot="17965567">
                <a:off x="3851684" y="4393548"/>
                <a:ext cx="49084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DNA</a:t>
                </a:r>
                <a:endPara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5" name="Straight Connector 54"/>
              <p:cNvCxnSpPr/>
              <p:nvPr/>
            </p:nvCxnSpPr>
            <p:spPr>
              <a:xfrm>
                <a:off x="3790919" y="4304424"/>
                <a:ext cx="458670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" name="Group 55"/>
            <p:cNvGrpSpPr/>
            <p:nvPr/>
          </p:nvGrpSpPr>
          <p:grpSpPr>
            <a:xfrm>
              <a:off x="4073911" y="3403660"/>
              <a:ext cx="628386" cy="661732"/>
              <a:chOff x="3734908" y="4100347"/>
              <a:chExt cx="628386" cy="661732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3752229" y="4100347"/>
                <a:ext cx="61106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nt 2</a:t>
                </a:r>
              </a:p>
            </p:txBody>
          </p:sp>
          <p:sp>
            <p:nvSpPr>
              <p:cNvPr id="58" name="Rectangle 57"/>
              <p:cNvSpPr/>
              <p:nvPr/>
            </p:nvSpPr>
            <p:spPr>
              <a:xfrm rot="17965567">
                <a:off x="3643858" y="4386536"/>
                <a:ext cx="42832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</a:t>
                </a:r>
              </a:p>
            </p:txBody>
          </p:sp>
          <p:sp>
            <p:nvSpPr>
              <p:cNvPr id="59" name="Rectangle 58"/>
              <p:cNvSpPr/>
              <p:nvPr/>
            </p:nvSpPr>
            <p:spPr>
              <a:xfrm rot="17965567">
                <a:off x="3851684" y="4393548"/>
                <a:ext cx="49084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DNA</a:t>
                </a:r>
                <a:endPara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0" name="Straight Connector 59"/>
              <p:cNvCxnSpPr/>
              <p:nvPr/>
            </p:nvCxnSpPr>
            <p:spPr>
              <a:xfrm>
                <a:off x="3790919" y="4304424"/>
                <a:ext cx="458670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" name="Group 60"/>
            <p:cNvGrpSpPr/>
            <p:nvPr/>
          </p:nvGrpSpPr>
          <p:grpSpPr>
            <a:xfrm>
              <a:off x="5267195" y="3407754"/>
              <a:ext cx="628386" cy="661732"/>
              <a:chOff x="3734908" y="4100347"/>
              <a:chExt cx="628386" cy="661732"/>
            </a:xfrm>
          </p:grpSpPr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3752229" y="4100347"/>
                <a:ext cx="61106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nt 4</a:t>
                </a:r>
              </a:p>
            </p:txBody>
          </p:sp>
          <p:sp>
            <p:nvSpPr>
              <p:cNvPr id="63" name="Rectangle 62"/>
              <p:cNvSpPr/>
              <p:nvPr/>
            </p:nvSpPr>
            <p:spPr>
              <a:xfrm rot="17965567">
                <a:off x="3643858" y="4386536"/>
                <a:ext cx="42832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</a:t>
                </a:r>
              </a:p>
            </p:txBody>
          </p:sp>
          <p:sp>
            <p:nvSpPr>
              <p:cNvPr id="64" name="Rectangle 63"/>
              <p:cNvSpPr/>
              <p:nvPr/>
            </p:nvSpPr>
            <p:spPr>
              <a:xfrm rot="17965567">
                <a:off x="3851684" y="4393548"/>
                <a:ext cx="49084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DNA</a:t>
                </a:r>
                <a:endPara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5" name="Straight Connector 64"/>
              <p:cNvCxnSpPr/>
              <p:nvPr/>
            </p:nvCxnSpPr>
            <p:spPr>
              <a:xfrm>
                <a:off x="3790919" y="4304424"/>
                <a:ext cx="458670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6" name="Group 65"/>
            <p:cNvGrpSpPr/>
            <p:nvPr/>
          </p:nvGrpSpPr>
          <p:grpSpPr>
            <a:xfrm>
              <a:off x="4690662" y="3405746"/>
              <a:ext cx="621855" cy="661732"/>
              <a:chOff x="3741439" y="4100347"/>
              <a:chExt cx="621855" cy="661732"/>
            </a:xfrm>
          </p:grpSpPr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3752229" y="4100347"/>
                <a:ext cx="61106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nt 3</a:t>
                </a:r>
              </a:p>
            </p:txBody>
          </p:sp>
          <p:sp>
            <p:nvSpPr>
              <p:cNvPr id="68" name="Rectangle 67"/>
              <p:cNvSpPr/>
              <p:nvPr/>
            </p:nvSpPr>
            <p:spPr>
              <a:xfrm rot="17965567">
                <a:off x="3650389" y="4386536"/>
                <a:ext cx="42832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</a:t>
                </a:r>
              </a:p>
            </p:txBody>
          </p:sp>
          <p:sp>
            <p:nvSpPr>
              <p:cNvPr id="69" name="Rectangle 68"/>
              <p:cNvSpPr/>
              <p:nvPr/>
            </p:nvSpPr>
            <p:spPr>
              <a:xfrm rot="17965567">
                <a:off x="3851684" y="4393548"/>
                <a:ext cx="49084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DNA</a:t>
                </a:r>
                <a:endPara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0" name="Straight Connector 69"/>
              <p:cNvCxnSpPr/>
              <p:nvPr/>
            </p:nvCxnSpPr>
            <p:spPr>
              <a:xfrm>
                <a:off x="3790919" y="4304424"/>
                <a:ext cx="458670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Group 70"/>
            <p:cNvGrpSpPr/>
            <p:nvPr/>
          </p:nvGrpSpPr>
          <p:grpSpPr>
            <a:xfrm>
              <a:off x="5852959" y="3400553"/>
              <a:ext cx="514681" cy="661732"/>
              <a:chOff x="3734908" y="4100347"/>
              <a:chExt cx="514681" cy="661732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F9A5B46-95C4-4F5F-8A44-485F4EAA8935}"/>
                  </a:ext>
                </a:extLst>
              </p:cNvPr>
              <p:cNvSpPr txBox="1"/>
              <p:nvPr/>
            </p:nvSpPr>
            <p:spPr>
              <a:xfrm>
                <a:off x="3804477" y="410034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73" name="Rectangle 72"/>
              <p:cNvSpPr/>
              <p:nvPr/>
            </p:nvSpPr>
            <p:spPr>
              <a:xfrm rot="17965567">
                <a:off x="3643858" y="4386536"/>
                <a:ext cx="42832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</a:t>
                </a:r>
              </a:p>
            </p:txBody>
          </p:sp>
          <p:sp>
            <p:nvSpPr>
              <p:cNvPr id="74" name="Rectangle 73"/>
              <p:cNvSpPr/>
              <p:nvPr/>
            </p:nvSpPr>
            <p:spPr>
              <a:xfrm rot="17965567">
                <a:off x="3851684" y="4393548"/>
                <a:ext cx="49084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0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DNA</a:t>
                </a:r>
                <a:endPara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5" name="Straight Connector 74"/>
              <p:cNvCxnSpPr/>
              <p:nvPr/>
            </p:nvCxnSpPr>
            <p:spPr>
              <a:xfrm>
                <a:off x="3790919" y="4304424"/>
                <a:ext cx="458670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76" name="Straight Arrow Connector 75"/>
          <p:cNvCxnSpPr/>
          <p:nvPr/>
        </p:nvCxnSpPr>
        <p:spPr>
          <a:xfrm>
            <a:off x="6260931" y="3359217"/>
            <a:ext cx="5688" cy="606339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4123872" y="3263463"/>
            <a:ext cx="205214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based genotyping were performed using gene specific and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DNA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</a:p>
        </p:txBody>
      </p:sp>
      <p:sp>
        <p:nvSpPr>
          <p:cNvPr id="5" name="Rectangle 4"/>
          <p:cNvSpPr/>
          <p:nvPr/>
        </p:nvSpPr>
        <p:spPr>
          <a:xfrm>
            <a:off x="109948" y="6040880"/>
            <a:ext cx="1193125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ps of PCR-based genotyping 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5g03350 gene-specific homozygous T-DNA insertion 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 1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, 3, and 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,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ere wild type (WT) plant was used as negative control for T-DNA specific amplification and gene specific primers were used as positive control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corresponds to wild type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thaliana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-0, while M corresponds to Marker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783342" y="153317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7081117" y="14642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6137867" y="209945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6873676" y="221674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4093901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3</TotalTime>
  <Words>121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Yogesh Mishra</dc:creator>
  <cp:lastModifiedBy>Dr.Yogesh Mishra</cp:lastModifiedBy>
  <cp:revision>40</cp:revision>
  <dcterms:created xsi:type="dcterms:W3CDTF">2022-04-29T09:33:20Z</dcterms:created>
  <dcterms:modified xsi:type="dcterms:W3CDTF">2022-05-13T05:27:34Z</dcterms:modified>
</cp:coreProperties>
</file>